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12192000" cy="54181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837"/>
    <a:srgbClr val="A6DBA0"/>
    <a:srgbClr val="7B329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6" autoAdjust="0"/>
    <p:restoredTop sz="77972" autoAdjust="0"/>
  </p:normalViewPr>
  <p:slideViewPr>
    <p:cSldViewPr snapToGrid="0">
      <p:cViewPr varScale="1">
        <p:scale>
          <a:sx n="107" d="100"/>
          <a:sy n="107" d="100"/>
        </p:scale>
        <p:origin x="38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\\s1filetu11.d01.arc.local\HBR\8%20PERSONAL\Sehr%20Stierschneider%20Lab\Mitarbeiter\Silvia\Maple\assembly\assembly_quality\Kopie%20von%20statistic_summary_comparing_all_species_v2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430577427821522E-2"/>
          <c:y val="0.12359172754563207"/>
          <c:w val="0.89513867016622917"/>
          <c:h val="0.648314415430518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ll!$G$9</c:f>
              <c:strCache>
                <c:ptCount val="1"/>
                <c:pt idx="0">
                  <c:v>P contigs with CRBB</c:v>
                </c:pt>
              </c:strCache>
            </c:strRef>
          </c:tx>
          <c:spPr>
            <a:solidFill>
              <a:srgbClr val="7B3294"/>
            </a:solidFill>
            <a:ln>
              <a:solidFill>
                <a:srgbClr val="7B3294"/>
              </a:solidFill>
            </a:ln>
            <a:effectLst/>
          </c:spPr>
          <c:invertIfNegative val="0"/>
          <c:cat>
            <c:strRef>
              <c:f>all!$B$10:$B$15</c:f>
              <c:strCache>
                <c:ptCount val="6"/>
                <c:pt idx="0">
                  <c:v>SO</c:v>
                </c:pt>
                <c:pt idx="1">
                  <c:v>TL</c:v>
                </c:pt>
                <c:pt idx="2">
                  <c:v>TR</c:v>
                </c:pt>
                <c:pt idx="3">
                  <c:v>SO</c:v>
                </c:pt>
                <c:pt idx="4">
                  <c:v>TL</c:v>
                </c:pt>
                <c:pt idx="5">
                  <c:v>TR</c:v>
                </c:pt>
              </c:strCache>
            </c:strRef>
          </c:cat>
          <c:val>
            <c:numRef>
              <c:f>all!$G$10:$G$15</c:f>
              <c:numCache>
                <c:formatCode>General</c:formatCode>
                <c:ptCount val="6"/>
                <c:pt idx="0">
                  <c:v>0.16506999999999999</c:v>
                </c:pt>
                <c:pt idx="1">
                  <c:v>0.21038000000000001</c:v>
                </c:pt>
                <c:pt idx="2">
                  <c:v>0.17216000000000001</c:v>
                </c:pt>
                <c:pt idx="3">
                  <c:v>9.2380000000000004E-2</c:v>
                </c:pt>
                <c:pt idx="4">
                  <c:v>0.28494000000000003</c:v>
                </c:pt>
                <c:pt idx="5">
                  <c:v>0.14874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C0-42D7-AFE6-2D376B831F2B}"/>
            </c:ext>
          </c:extLst>
        </c:ser>
        <c:ser>
          <c:idx val="1"/>
          <c:order val="1"/>
          <c:tx>
            <c:strRef>
              <c:f>all!$H$9</c:f>
              <c:strCache>
                <c:ptCount val="1"/>
                <c:pt idx="0">
                  <c:v>P reference with CRBB</c:v>
                </c:pt>
              </c:strCache>
            </c:strRef>
          </c:tx>
          <c:spPr>
            <a:solidFill>
              <a:srgbClr val="A6DBA0"/>
            </a:solidFill>
            <a:ln>
              <a:solidFill>
                <a:srgbClr val="A6DBA0"/>
              </a:solidFill>
            </a:ln>
            <a:effectLst/>
          </c:spPr>
          <c:invertIfNegative val="0"/>
          <c:cat>
            <c:strRef>
              <c:f>all!$B$10:$B$15</c:f>
              <c:strCache>
                <c:ptCount val="6"/>
                <c:pt idx="0">
                  <c:v>SO</c:v>
                </c:pt>
                <c:pt idx="1">
                  <c:v>TL</c:v>
                </c:pt>
                <c:pt idx="2">
                  <c:v>TR</c:v>
                </c:pt>
                <c:pt idx="3">
                  <c:v>SO</c:v>
                </c:pt>
                <c:pt idx="4">
                  <c:v>TL</c:v>
                </c:pt>
                <c:pt idx="5">
                  <c:v>TR</c:v>
                </c:pt>
              </c:strCache>
            </c:strRef>
          </c:cat>
          <c:val>
            <c:numRef>
              <c:f>all!$H$10:$H$15</c:f>
              <c:numCache>
                <c:formatCode>General</c:formatCode>
                <c:ptCount val="6"/>
                <c:pt idx="0">
                  <c:v>0.54784999999999995</c:v>
                </c:pt>
                <c:pt idx="1">
                  <c:v>0.57447000000000004</c:v>
                </c:pt>
                <c:pt idx="2">
                  <c:v>0.59911999999999999</c:v>
                </c:pt>
                <c:pt idx="3">
                  <c:v>0.58828000000000003</c:v>
                </c:pt>
                <c:pt idx="4">
                  <c:v>0.64363999999999999</c:v>
                </c:pt>
                <c:pt idx="5">
                  <c:v>0.7058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2C0-42D7-AFE6-2D376B831F2B}"/>
            </c:ext>
          </c:extLst>
        </c:ser>
        <c:ser>
          <c:idx val="2"/>
          <c:order val="2"/>
          <c:tx>
            <c:strRef>
              <c:f>all!$I$9</c:f>
              <c:strCache>
                <c:ptCount val="1"/>
                <c:pt idx="0">
                  <c:v>Reference coverage</c:v>
                </c:pt>
              </c:strCache>
            </c:strRef>
          </c:tx>
          <c:spPr>
            <a:solidFill>
              <a:srgbClr val="008837"/>
            </a:solidFill>
            <a:ln>
              <a:solidFill>
                <a:srgbClr val="008837"/>
              </a:solidFill>
            </a:ln>
            <a:effectLst/>
          </c:spPr>
          <c:invertIfNegative val="0"/>
          <c:cat>
            <c:strRef>
              <c:f>all!$B$10:$B$15</c:f>
              <c:strCache>
                <c:ptCount val="6"/>
                <c:pt idx="0">
                  <c:v>SO</c:v>
                </c:pt>
                <c:pt idx="1">
                  <c:v>TL</c:v>
                </c:pt>
                <c:pt idx="2">
                  <c:v>TR</c:v>
                </c:pt>
                <c:pt idx="3">
                  <c:v>SO</c:v>
                </c:pt>
                <c:pt idx="4">
                  <c:v>TL</c:v>
                </c:pt>
                <c:pt idx="5">
                  <c:v>TR</c:v>
                </c:pt>
              </c:strCache>
            </c:strRef>
          </c:cat>
          <c:val>
            <c:numRef>
              <c:f>all!$I$10:$I$15</c:f>
              <c:numCache>
                <c:formatCode>General</c:formatCode>
                <c:ptCount val="6"/>
                <c:pt idx="0">
                  <c:v>0.36893999999999999</c:v>
                </c:pt>
                <c:pt idx="1">
                  <c:v>0.44229000000000002</c:v>
                </c:pt>
                <c:pt idx="2">
                  <c:v>0.45290999999999998</c:v>
                </c:pt>
                <c:pt idx="3">
                  <c:v>0.33801999999999999</c:v>
                </c:pt>
                <c:pt idx="4">
                  <c:v>0.57081000000000004</c:v>
                </c:pt>
                <c:pt idx="5">
                  <c:v>0.57333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2C0-42D7-AFE6-2D376B831F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02951784"/>
        <c:axId val="602947848"/>
      </c:barChart>
      <c:catAx>
        <c:axId val="602951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>
                <a:lumMod val="65000"/>
                <a:lumOff val="35000"/>
              </a:sys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2947848"/>
        <c:crosses val="autoZero"/>
        <c:auto val="1"/>
        <c:lblAlgn val="ctr"/>
        <c:lblOffset val="100"/>
        <c:noMultiLvlLbl val="0"/>
      </c:catAx>
      <c:valAx>
        <c:axId val="60294784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>
                <a:lumMod val="65000"/>
                <a:lumOff val="3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29517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1521698544480792E-2"/>
          <c:y val="4.1090724908626815E-2"/>
          <c:w val="0.92141648528474818"/>
          <c:h val="0.7948096267009119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rabidopsis!$H$1</c:f>
              <c:strCache>
                <c:ptCount val="1"/>
                <c:pt idx="0">
                  <c:v>P contigs with CRBB</c:v>
                </c:pt>
              </c:strCache>
            </c:strRef>
          </c:tx>
          <c:spPr>
            <a:solidFill>
              <a:srgbClr val="7B3294"/>
            </a:solidFill>
            <a:ln>
              <a:solidFill>
                <a:srgbClr val="7B3294"/>
              </a:solidFill>
            </a:ln>
            <a:effectLst/>
          </c:spPr>
          <c:invertIfNegative val="0"/>
          <c:cat>
            <c:strRef>
              <c:f>arabidopsis!$C$2:$C$7</c:f>
              <c:strCache>
                <c:ptCount val="6"/>
                <c:pt idx="0">
                  <c:v>SO</c:v>
                </c:pt>
                <c:pt idx="1">
                  <c:v>TL</c:v>
                </c:pt>
                <c:pt idx="2">
                  <c:v>TR</c:v>
                </c:pt>
                <c:pt idx="3">
                  <c:v>SO</c:v>
                </c:pt>
                <c:pt idx="4">
                  <c:v>TL</c:v>
                </c:pt>
                <c:pt idx="5">
                  <c:v>TR</c:v>
                </c:pt>
              </c:strCache>
            </c:strRef>
          </c:cat>
          <c:val>
            <c:numRef>
              <c:f>arabidopsis!$H$2:$H$7</c:f>
              <c:numCache>
                <c:formatCode>0.00</c:formatCode>
                <c:ptCount val="6"/>
                <c:pt idx="0">
                  <c:v>0.3674</c:v>
                </c:pt>
                <c:pt idx="1">
                  <c:v>0.77893999999999997</c:v>
                </c:pt>
                <c:pt idx="2">
                  <c:v>0.68789</c:v>
                </c:pt>
                <c:pt idx="3">
                  <c:v>0.35977999999999999</c:v>
                </c:pt>
                <c:pt idx="4">
                  <c:v>0.78139999999999998</c:v>
                </c:pt>
                <c:pt idx="5">
                  <c:v>0.698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01-4BFF-867F-CEF922330FB4}"/>
            </c:ext>
          </c:extLst>
        </c:ser>
        <c:ser>
          <c:idx val="1"/>
          <c:order val="1"/>
          <c:tx>
            <c:strRef>
              <c:f>arabidopsis!$I$1</c:f>
              <c:strCache>
                <c:ptCount val="1"/>
                <c:pt idx="0">
                  <c:v>P reference with CRBB</c:v>
                </c:pt>
              </c:strCache>
            </c:strRef>
          </c:tx>
          <c:spPr>
            <a:solidFill>
              <a:srgbClr val="A6DBA0"/>
            </a:solidFill>
            <a:ln>
              <a:solidFill>
                <a:srgbClr val="A6DBA0"/>
              </a:solidFill>
            </a:ln>
            <a:effectLst/>
          </c:spPr>
          <c:invertIfNegative val="0"/>
          <c:cat>
            <c:strRef>
              <c:f>arabidopsis!$C$2:$C$7</c:f>
              <c:strCache>
                <c:ptCount val="6"/>
                <c:pt idx="0">
                  <c:v>SO</c:v>
                </c:pt>
                <c:pt idx="1">
                  <c:v>TL</c:v>
                </c:pt>
                <c:pt idx="2">
                  <c:v>TR</c:v>
                </c:pt>
                <c:pt idx="3">
                  <c:v>SO</c:v>
                </c:pt>
                <c:pt idx="4">
                  <c:v>TL</c:v>
                </c:pt>
                <c:pt idx="5">
                  <c:v>TR</c:v>
                </c:pt>
              </c:strCache>
            </c:strRef>
          </c:cat>
          <c:val>
            <c:numRef>
              <c:f>arabidopsis!$I$2:$I$7</c:f>
              <c:numCache>
                <c:formatCode>0.00</c:formatCode>
                <c:ptCount val="6"/>
                <c:pt idx="0">
                  <c:v>0.42147000000000001</c:v>
                </c:pt>
                <c:pt idx="1">
                  <c:v>0.40748000000000001</c:v>
                </c:pt>
                <c:pt idx="2">
                  <c:v>0.47338000000000002</c:v>
                </c:pt>
                <c:pt idx="3">
                  <c:v>0.41937999999999998</c:v>
                </c:pt>
                <c:pt idx="4">
                  <c:v>0.44562000000000002</c:v>
                </c:pt>
                <c:pt idx="5">
                  <c:v>0.47655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F01-4BFF-867F-CEF922330FB4}"/>
            </c:ext>
          </c:extLst>
        </c:ser>
        <c:ser>
          <c:idx val="2"/>
          <c:order val="2"/>
          <c:tx>
            <c:strRef>
              <c:f>arabidopsis!$J$1</c:f>
              <c:strCache>
                <c:ptCount val="1"/>
                <c:pt idx="0">
                  <c:v>Reference coverage</c:v>
                </c:pt>
              </c:strCache>
            </c:strRef>
          </c:tx>
          <c:spPr>
            <a:solidFill>
              <a:srgbClr val="008837"/>
            </a:solidFill>
            <a:ln>
              <a:solidFill>
                <a:srgbClr val="008837"/>
              </a:solidFill>
            </a:ln>
            <a:effectLst/>
          </c:spPr>
          <c:invertIfNegative val="0"/>
          <c:cat>
            <c:strRef>
              <c:f>arabidopsis!$C$2:$C$7</c:f>
              <c:strCache>
                <c:ptCount val="6"/>
                <c:pt idx="0">
                  <c:v>SO</c:v>
                </c:pt>
                <c:pt idx="1">
                  <c:v>TL</c:v>
                </c:pt>
                <c:pt idx="2">
                  <c:v>TR</c:v>
                </c:pt>
                <c:pt idx="3">
                  <c:v>SO</c:v>
                </c:pt>
                <c:pt idx="4">
                  <c:v>TL</c:v>
                </c:pt>
                <c:pt idx="5">
                  <c:v>TR</c:v>
                </c:pt>
              </c:strCache>
            </c:strRef>
          </c:cat>
          <c:val>
            <c:numRef>
              <c:f>arabidopsis!$J$2:$J$7</c:f>
              <c:numCache>
                <c:formatCode>General</c:formatCode>
                <c:ptCount val="6"/>
                <c:pt idx="0">
                  <c:v>0.33365</c:v>
                </c:pt>
                <c:pt idx="1">
                  <c:v>0.40000999999999998</c:v>
                </c:pt>
                <c:pt idx="2">
                  <c:v>0.43862000000000001</c:v>
                </c:pt>
                <c:pt idx="3">
                  <c:v>0.33535999999999999</c:v>
                </c:pt>
                <c:pt idx="4">
                  <c:v>0.43174000000000001</c:v>
                </c:pt>
                <c:pt idx="5">
                  <c:v>0.441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F01-4BFF-867F-CEF922330F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8757200"/>
        <c:axId val="498754904"/>
      </c:barChart>
      <c:catAx>
        <c:axId val="4987572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>
                <a:lumMod val="65000"/>
                <a:lumOff val="35000"/>
              </a:sys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8754904"/>
        <c:crosses val="autoZero"/>
        <c:auto val="1"/>
        <c:lblAlgn val="ctr"/>
        <c:lblOffset val="100"/>
        <c:noMultiLvlLbl val="0"/>
      </c:catAx>
      <c:valAx>
        <c:axId val="498754904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solidFill>
              <a:sysClr val="windowText" lastClr="000000">
                <a:lumMod val="65000"/>
                <a:lumOff val="3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87572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91B87C-C90B-4DE6-82B8-86D566F36BE7}" type="datetimeFigureOut">
              <a:rPr lang="en-GB" smtClean="0"/>
              <a:t>09/11/2020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-42863" y="1143000"/>
            <a:ext cx="6943726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F8862B-B0EF-4FCE-815F-5B286CF805A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53856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Font typeface="Arial" panose="020B0604020202020204" pitchFamily="34" charset="0"/>
              <a:buNone/>
            </a:pP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ditional file 4: Comparison of </a:t>
            </a:r>
            <a:r>
              <a:rPr lang="en-US" sz="1200" b="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abidopsis thaliana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US" sz="1200" b="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er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ssemblies to the respective reference protein sets. </a:t>
            </a:r>
            <a:r>
              <a:rPr lang="en-GB" b="0" dirty="0"/>
              <a:t>P contigs with CRBB - the proportion of contigs with a CRB-BLAST hit; P reference with CRBB - the proportion of references with CRB-BLAST hit; Reference coverage - </a:t>
            </a:r>
            <a:r>
              <a:rPr lang="en-US" b="0" dirty="0"/>
              <a:t>the proportion of reference amino acids covered by a CRB-BLAST hit</a:t>
            </a:r>
            <a:endParaRPr lang="en-GB" b="0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F8862B-B0EF-4FCE-815F-5B286CF805AA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48098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886719"/>
            <a:ext cx="9144000" cy="1886315"/>
          </a:xfrm>
        </p:spPr>
        <p:txBody>
          <a:bodyPr anchor="b"/>
          <a:lstStyle>
            <a:lvl1pPr algn="ctr">
              <a:defRPr sz="474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2845777"/>
            <a:ext cx="9144000" cy="1308129"/>
          </a:xfrm>
        </p:spPr>
        <p:txBody>
          <a:bodyPr/>
          <a:lstStyle>
            <a:lvl1pPr marL="0" indent="0" algn="ctr">
              <a:buNone/>
              <a:defRPr sz="1896"/>
            </a:lvl1pPr>
            <a:lvl2pPr marL="361188" indent="0" algn="ctr">
              <a:buNone/>
              <a:defRPr sz="1580"/>
            </a:lvl2pPr>
            <a:lvl3pPr marL="722376" indent="0" algn="ctr">
              <a:buNone/>
              <a:defRPr sz="1422"/>
            </a:lvl3pPr>
            <a:lvl4pPr marL="1083564" indent="0" algn="ctr">
              <a:buNone/>
              <a:defRPr sz="1264"/>
            </a:lvl4pPr>
            <a:lvl5pPr marL="1444752" indent="0" algn="ctr">
              <a:buNone/>
              <a:defRPr sz="1264"/>
            </a:lvl5pPr>
            <a:lvl6pPr marL="1805940" indent="0" algn="ctr">
              <a:buNone/>
              <a:defRPr sz="1264"/>
            </a:lvl6pPr>
            <a:lvl7pPr marL="2167128" indent="0" algn="ctr">
              <a:buNone/>
              <a:defRPr sz="1264"/>
            </a:lvl7pPr>
            <a:lvl8pPr marL="2528316" indent="0" algn="ctr">
              <a:buNone/>
              <a:defRPr sz="1264"/>
            </a:lvl8pPr>
            <a:lvl9pPr marL="2889504" indent="0" algn="ctr">
              <a:buNone/>
              <a:defRPr sz="1264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656A-018F-4287-B655-E10EE5BC23C5}" type="datetimeFigureOut">
              <a:rPr lang="en-GB" smtClean="0"/>
              <a:t>09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2D6D9-2231-4D58-9382-FBAD73C9B35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2708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656A-018F-4287-B655-E10EE5BC23C5}" type="datetimeFigureOut">
              <a:rPr lang="en-GB" smtClean="0"/>
              <a:t>09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2D6D9-2231-4D58-9382-FBAD73C9B35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6917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288465"/>
            <a:ext cx="2628900" cy="4591622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288465"/>
            <a:ext cx="7734300" cy="4591622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656A-018F-4287-B655-E10EE5BC23C5}" type="datetimeFigureOut">
              <a:rPr lang="en-GB" smtClean="0"/>
              <a:t>09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2D6D9-2231-4D58-9382-FBAD73C9B35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1033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656A-018F-4287-B655-E10EE5BC23C5}" type="datetimeFigureOut">
              <a:rPr lang="en-GB" smtClean="0"/>
              <a:t>09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2D6D9-2231-4D58-9382-FBAD73C9B35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2797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350772"/>
            <a:ext cx="10515600" cy="2253795"/>
          </a:xfrm>
        </p:spPr>
        <p:txBody>
          <a:bodyPr anchor="b"/>
          <a:lstStyle>
            <a:lvl1pPr>
              <a:defRPr sz="474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3625889"/>
            <a:ext cx="10515600" cy="1185217"/>
          </a:xfrm>
        </p:spPr>
        <p:txBody>
          <a:bodyPr/>
          <a:lstStyle>
            <a:lvl1pPr marL="0" indent="0">
              <a:buNone/>
              <a:defRPr sz="1896">
                <a:solidFill>
                  <a:schemeClr val="tx1">
                    <a:tint val="75000"/>
                  </a:schemeClr>
                </a:solidFill>
              </a:defRPr>
            </a:lvl1pPr>
            <a:lvl2pPr marL="361188" indent="0">
              <a:buNone/>
              <a:defRPr sz="1580">
                <a:solidFill>
                  <a:schemeClr val="tx1">
                    <a:tint val="75000"/>
                  </a:schemeClr>
                </a:solidFill>
              </a:defRPr>
            </a:lvl2pPr>
            <a:lvl3pPr marL="722376" indent="0">
              <a:buNone/>
              <a:defRPr sz="1422">
                <a:solidFill>
                  <a:schemeClr val="tx1">
                    <a:tint val="75000"/>
                  </a:schemeClr>
                </a:solidFill>
              </a:defRPr>
            </a:lvl3pPr>
            <a:lvl4pPr marL="1083564" indent="0">
              <a:buNone/>
              <a:defRPr sz="1264">
                <a:solidFill>
                  <a:schemeClr val="tx1">
                    <a:tint val="75000"/>
                  </a:schemeClr>
                </a:solidFill>
              </a:defRPr>
            </a:lvl4pPr>
            <a:lvl5pPr marL="1444752" indent="0">
              <a:buNone/>
              <a:defRPr sz="1264">
                <a:solidFill>
                  <a:schemeClr val="tx1">
                    <a:tint val="75000"/>
                  </a:schemeClr>
                </a:solidFill>
              </a:defRPr>
            </a:lvl5pPr>
            <a:lvl6pPr marL="1805940" indent="0">
              <a:buNone/>
              <a:defRPr sz="1264">
                <a:solidFill>
                  <a:schemeClr val="tx1">
                    <a:tint val="75000"/>
                  </a:schemeClr>
                </a:solidFill>
              </a:defRPr>
            </a:lvl6pPr>
            <a:lvl7pPr marL="2167128" indent="0">
              <a:buNone/>
              <a:defRPr sz="1264">
                <a:solidFill>
                  <a:schemeClr val="tx1">
                    <a:tint val="75000"/>
                  </a:schemeClr>
                </a:solidFill>
              </a:defRPr>
            </a:lvl7pPr>
            <a:lvl8pPr marL="2528316" indent="0">
              <a:buNone/>
              <a:defRPr sz="1264">
                <a:solidFill>
                  <a:schemeClr val="tx1">
                    <a:tint val="75000"/>
                  </a:schemeClr>
                </a:solidFill>
              </a:defRPr>
            </a:lvl8pPr>
            <a:lvl9pPr marL="2889504" indent="0">
              <a:buNone/>
              <a:defRPr sz="12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656A-018F-4287-B655-E10EE5BC23C5}" type="datetimeFigureOut">
              <a:rPr lang="en-GB" smtClean="0"/>
              <a:t>09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2D6D9-2231-4D58-9382-FBAD73C9B35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1282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442328"/>
            <a:ext cx="5181600" cy="343775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442328"/>
            <a:ext cx="5181600" cy="343775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656A-018F-4287-B655-E10EE5BC23C5}" type="datetimeFigureOut">
              <a:rPr lang="en-GB" smtClean="0"/>
              <a:t>09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2D6D9-2231-4D58-9382-FBAD73C9B35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3232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288466"/>
            <a:ext cx="10515600" cy="1047256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328197"/>
            <a:ext cx="5157787" cy="650929"/>
          </a:xfrm>
        </p:spPr>
        <p:txBody>
          <a:bodyPr anchor="b"/>
          <a:lstStyle>
            <a:lvl1pPr marL="0" indent="0">
              <a:buNone/>
              <a:defRPr sz="1896" b="1"/>
            </a:lvl1pPr>
            <a:lvl2pPr marL="361188" indent="0">
              <a:buNone/>
              <a:defRPr sz="1580" b="1"/>
            </a:lvl2pPr>
            <a:lvl3pPr marL="722376" indent="0">
              <a:buNone/>
              <a:defRPr sz="1422" b="1"/>
            </a:lvl3pPr>
            <a:lvl4pPr marL="1083564" indent="0">
              <a:buNone/>
              <a:defRPr sz="1264" b="1"/>
            </a:lvl4pPr>
            <a:lvl5pPr marL="1444752" indent="0">
              <a:buNone/>
              <a:defRPr sz="1264" b="1"/>
            </a:lvl5pPr>
            <a:lvl6pPr marL="1805940" indent="0">
              <a:buNone/>
              <a:defRPr sz="1264" b="1"/>
            </a:lvl6pPr>
            <a:lvl7pPr marL="2167128" indent="0">
              <a:buNone/>
              <a:defRPr sz="1264" b="1"/>
            </a:lvl7pPr>
            <a:lvl8pPr marL="2528316" indent="0">
              <a:buNone/>
              <a:defRPr sz="1264" b="1"/>
            </a:lvl8pPr>
            <a:lvl9pPr marL="2889504" indent="0">
              <a:buNone/>
              <a:defRPr sz="1264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1979126"/>
            <a:ext cx="5157787" cy="291099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328197"/>
            <a:ext cx="5183188" cy="650929"/>
          </a:xfrm>
        </p:spPr>
        <p:txBody>
          <a:bodyPr anchor="b"/>
          <a:lstStyle>
            <a:lvl1pPr marL="0" indent="0">
              <a:buNone/>
              <a:defRPr sz="1896" b="1"/>
            </a:lvl1pPr>
            <a:lvl2pPr marL="361188" indent="0">
              <a:buNone/>
              <a:defRPr sz="1580" b="1"/>
            </a:lvl2pPr>
            <a:lvl3pPr marL="722376" indent="0">
              <a:buNone/>
              <a:defRPr sz="1422" b="1"/>
            </a:lvl3pPr>
            <a:lvl4pPr marL="1083564" indent="0">
              <a:buNone/>
              <a:defRPr sz="1264" b="1"/>
            </a:lvl4pPr>
            <a:lvl5pPr marL="1444752" indent="0">
              <a:buNone/>
              <a:defRPr sz="1264" b="1"/>
            </a:lvl5pPr>
            <a:lvl6pPr marL="1805940" indent="0">
              <a:buNone/>
              <a:defRPr sz="1264" b="1"/>
            </a:lvl6pPr>
            <a:lvl7pPr marL="2167128" indent="0">
              <a:buNone/>
              <a:defRPr sz="1264" b="1"/>
            </a:lvl7pPr>
            <a:lvl8pPr marL="2528316" indent="0">
              <a:buNone/>
              <a:defRPr sz="1264" b="1"/>
            </a:lvl8pPr>
            <a:lvl9pPr marL="2889504" indent="0">
              <a:buNone/>
              <a:defRPr sz="1264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1979126"/>
            <a:ext cx="5183188" cy="291099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656A-018F-4287-B655-E10EE5BC23C5}" type="datetimeFigureOut">
              <a:rPr lang="en-GB" smtClean="0"/>
              <a:t>09/1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2D6D9-2231-4D58-9382-FBAD73C9B35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75082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656A-018F-4287-B655-E10EE5BC23C5}" type="datetimeFigureOut">
              <a:rPr lang="en-GB" smtClean="0"/>
              <a:t>09/1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2D6D9-2231-4D58-9382-FBAD73C9B35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6193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656A-018F-4287-B655-E10EE5BC23C5}" type="datetimeFigureOut">
              <a:rPr lang="en-GB" smtClean="0"/>
              <a:t>09/1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2D6D9-2231-4D58-9382-FBAD73C9B35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4295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1209"/>
            <a:ext cx="3932237" cy="1264232"/>
          </a:xfrm>
        </p:spPr>
        <p:txBody>
          <a:bodyPr anchor="b"/>
          <a:lstStyle>
            <a:lvl1pPr>
              <a:defRPr sz="2528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780112"/>
            <a:ext cx="6172200" cy="3850390"/>
          </a:xfrm>
        </p:spPr>
        <p:txBody>
          <a:bodyPr/>
          <a:lstStyle>
            <a:lvl1pPr>
              <a:defRPr sz="2528"/>
            </a:lvl1pPr>
            <a:lvl2pPr>
              <a:defRPr sz="2212"/>
            </a:lvl2pPr>
            <a:lvl3pPr>
              <a:defRPr sz="1896"/>
            </a:lvl3pPr>
            <a:lvl4pPr>
              <a:defRPr sz="1580"/>
            </a:lvl4pPr>
            <a:lvl5pPr>
              <a:defRPr sz="1580"/>
            </a:lvl5pPr>
            <a:lvl6pPr>
              <a:defRPr sz="1580"/>
            </a:lvl6pPr>
            <a:lvl7pPr>
              <a:defRPr sz="1580"/>
            </a:lvl7pPr>
            <a:lvl8pPr>
              <a:defRPr sz="1580"/>
            </a:lvl8pPr>
            <a:lvl9pPr>
              <a:defRPr sz="158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1625442"/>
            <a:ext cx="3932237" cy="3011331"/>
          </a:xfrm>
        </p:spPr>
        <p:txBody>
          <a:bodyPr/>
          <a:lstStyle>
            <a:lvl1pPr marL="0" indent="0">
              <a:buNone/>
              <a:defRPr sz="1264"/>
            </a:lvl1pPr>
            <a:lvl2pPr marL="361188" indent="0">
              <a:buNone/>
              <a:defRPr sz="1106"/>
            </a:lvl2pPr>
            <a:lvl3pPr marL="722376" indent="0">
              <a:buNone/>
              <a:defRPr sz="948"/>
            </a:lvl3pPr>
            <a:lvl4pPr marL="1083564" indent="0">
              <a:buNone/>
              <a:defRPr sz="790"/>
            </a:lvl4pPr>
            <a:lvl5pPr marL="1444752" indent="0">
              <a:buNone/>
              <a:defRPr sz="790"/>
            </a:lvl5pPr>
            <a:lvl6pPr marL="1805940" indent="0">
              <a:buNone/>
              <a:defRPr sz="790"/>
            </a:lvl6pPr>
            <a:lvl7pPr marL="2167128" indent="0">
              <a:buNone/>
              <a:defRPr sz="790"/>
            </a:lvl7pPr>
            <a:lvl8pPr marL="2528316" indent="0">
              <a:buNone/>
              <a:defRPr sz="790"/>
            </a:lvl8pPr>
            <a:lvl9pPr marL="2889504" indent="0">
              <a:buNone/>
              <a:defRPr sz="79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656A-018F-4287-B655-E10EE5BC23C5}" type="datetimeFigureOut">
              <a:rPr lang="en-GB" smtClean="0"/>
              <a:t>09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2D6D9-2231-4D58-9382-FBAD73C9B35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1639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1209"/>
            <a:ext cx="3932237" cy="1264232"/>
          </a:xfrm>
        </p:spPr>
        <p:txBody>
          <a:bodyPr anchor="b"/>
          <a:lstStyle>
            <a:lvl1pPr>
              <a:defRPr sz="2528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780112"/>
            <a:ext cx="6172200" cy="3850390"/>
          </a:xfrm>
        </p:spPr>
        <p:txBody>
          <a:bodyPr anchor="t"/>
          <a:lstStyle>
            <a:lvl1pPr marL="0" indent="0">
              <a:buNone/>
              <a:defRPr sz="2528"/>
            </a:lvl1pPr>
            <a:lvl2pPr marL="361188" indent="0">
              <a:buNone/>
              <a:defRPr sz="2212"/>
            </a:lvl2pPr>
            <a:lvl3pPr marL="722376" indent="0">
              <a:buNone/>
              <a:defRPr sz="1896"/>
            </a:lvl3pPr>
            <a:lvl4pPr marL="1083564" indent="0">
              <a:buNone/>
              <a:defRPr sz="1580"/>
            </a:lvl4pPr>
            <a:lvl5pPr marL="1444752" indent="0">
              <a:buNone/>
              <a:defRPr sz="1580"/>
            </a:lvl5pPr>
            <a:lvl6pPr marL="1805940" indent="0">
              <a:buNone/>
              <a:defRPr sz="1580"/>
            </a:lvl6pPr>
            <a:lvl7pPr marL="2167128" indent="0">
              <a:buNone/>
              <a:defRPr sz="1580"/>
            </a:lvl7pPr>
            <a:lvl8pPr marL="2528316" indent="0">
              <a:buNone/>
              <a:defRPr sz="1580"/>
            </a:lvl8pPr>
            <a:lvl9pPr marL="2889504" indent="0">
              <a:buNone/>
              <a:defRPr sz="158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1625442"/>
            <a:ext cx="3932237" cy="3011331"/>
          </a:xfrm>
        </p:spPr>
        <p:txBody>
          <a:bodyPr/>
          <a:lstStyle>
            <a:lvl1pPr marL="0" indent="0">
              <a:buNone/>
              <a:defRPr sz="1264"/>
            </a:lvl1pPr>
            <a:lvl2pPr marL="361188" indent="0">
              <a:buNone/>
              <a:defRPr sz="1106"/>
            </a:lvl2pPr>
            <a:lvl3pPr marL="722376" indent="0">
              <a:buNone/>
              <a:defRPr sz="948"/>
            </a:lvl3pPr>
            <a:lvl4pPr marL="1083564" indent="0">
              <a:buNone/>
              <a:defRPr sz="790"/>
            </a:lvl4pPr>
            <a:lvl5pPr marL="1444752" indent="0">
              <a:buNone/>
              <a:defRPr sz="790"/>
            </a:lvl5pPr>
            <a:lvl6pPr marL="1805940" indent="0">
              <a:buNone/>
              <a:defRPr sz="790"/>
            </a:lvl6pPr>
            <a:lvl7pPr marL="2167128" indent="0">
              <a:buNone/>
              <a:defRPr sz="790"/>
            </a:lvl7pPr>
            <a:lvl8pPr marL="2528316" indent="0">
              <a:buNone/>
              <a:defRPr sz="790"/>
            </a:lvl8pPr>
            <a:lvl9pPr marL="2889504" indent="0">
              <a:buNone/>
              <a:defRPr sz="79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7656A-018F-4287-B655-E10EE5BC23C5}" type="datetimeFigureOut">
              <a:rPr lang="en-GB" smtClean="0"/>
              <a:t>09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2D6D9-2231-4D58-9382-FBAD73C9B35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2366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288466"/>
            <a:ext cx="10515600" cy="10472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442328"/>
            <a:ext cx="10515600" cy="34377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5021811"/>
            <a:ext cx="2743200" cy="28846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B7656A-018F-4287-B655-E10EE5BC23C5}" type="datetimeFigureOut">
              <a:rPr lang="en-GB" smtClean="0"/>
              <a:t>09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5021811"/>
            <a:ext cx="4114800" cy="28846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5021811"/>
            <a:ext cx="2743200" cy="28846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62D6D9-2231-4D58-9382-FBAD73C9B35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97404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22376" rtl="0" eaLnBrk="1" latinLnBrk="0" hangingPunct="1">
        <a:lnSpc>
          <a:spcPct val="90000"/>
        </a:lnSpc>
        <a:spcBef>
          <a:spcPct val="0"/>
        </a:spcBef>
        <a:buNone/>
        <a:defRPr sz="347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0594" indent="-180594" algn="l" defTabSz="722376" rtl="0" eaLnBrk="1" latinLnBrk="0" hangingPunct="1">
        <a:lnSpc>
          <a:spcPct val="90000"/>
        </a:lnSpc>
        <a:spcBef>
          <a:spcPts val="790"/>
        </a:spcBef>
        <a:buFont typeface="Arial" panose="020B0604020202020204" pitchFamily="34" charset="0"/>
        <a:buChar char="•"/>
        <a:defRPr sz="2212" kern="1200">
          <a:solidFill>
            <a:schemeClr val="tx1"/>
          </a:solidFill>
          <a:latin typeface="+mn-lt"/>
          <a:ea typeface="+mn-ea"/>
          <a:cs typeface="+mn-cs"/>
        </a:defRPr>
      </a:lvl1pPr>
      <a:lvl2pPr marL="541782" indent="-180594" algn="l" defTabSz="722376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896" kern="1200">
          <a:solidFill>
            <a:schemeClr val="tx1"/>
          </a:solidFill>
          <a:latin typeface="+mn-lt"/>
          <a:ea typeface="+mn-ea"/>
          <a:cs typeface="+mn-cs"/>
        </a:defRPr>
      </a:lvl2pPr>
      <a:lvl3pPr marL="902970" indent="-180594" algn="l" defTabSz="722376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580" kern="1200">
          <a:solidFill>
            <a:schemeClr val="tx1"/>
          </a:solidFill>
          <a:latin typeface="+mn-lt"/>
          <a:ea typeface="+mn-ea"/>
          <a:cs typeface="+mn-cs"/>
        </a:defRPr>
      </a:lvl3pPr>
      <a:lvl4pPr marL="1264158" indent="-180594" algn="l" defTabSz="722376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422" kern="1200">
          <a:solidFill>
            <a:schemeClr val="tx1"/>
          </a:solidFill>
          <a:latin typeface="+mn-lt"/>
          <a:ea typeface="+mn-ea"/>
          <a:cs typeface="+mn-cs"/>
        </a:defRPr>
      </a:lvl4pPr>
      <a:lvl5pPr marL="1625346" indent="-180594" algn="l" defTabSz="722376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422" kern="1200">
          <a:solidFill>
            <a:schemeClr val="tx1"/>
          </a:solidFill>
          <a:latin typeface="+mn-lt"/>
          <a:ea typeface="+mn-ea"/>
          <a:cs typeface="+mn-cs"/>
        </a:defRPr>
      </a:lvl5pPr>
      <a:lvl6pPr marL="1986534" indent="-180594" algn="l" defTabSz="722376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422" kern="1200">
          <a:solidFill>
            <a:schemeClr val="tx1"/>
          </a:solidFill>
          <a:latin typeface="+mn-lt"/>
          <a:ea typeface="+mn-ea"/>
          <a:cs typeface="+mn-cs"/>
        </a:defRPr>
      </a:lvl6pPr>
      <a:lvl7pPr marL="2347722" indent="-180594" algn="l" defTabSz="722376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422" kern="1200">
          <a:solidFill>
            <a:schemeClr val="tx1"/>
          </a:solidFill>
          <a:latin typeface="+mn-lt"/>
          <a:ea typeface="+mn-ea"/>
          <a:cs typeface="+mn-cs"/>
        </a:defRPr>
      </a:lvl7pPr>
      <a:lvl8pPr marL="2708910" indent="-180594" algn="l" defTabSz="722376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422" kern="1200">
          <a:solidFill>
            <a:schemeClr val="tx1"/>
          </a:solidFill>
          <a:latin typeface="+mn-lt"/>
          <a:ea typeface="+mn-ea"/>
          <a:cs typeface="+mn-cs"/>
        </a:defRPr>
      </a:lvl8pPr>
      <a:lvl9pPr marL="3070098" indent="-180594" algn="l" defTabSz="722376" rtl="0" eaLnBrk="1" latinLnBrk="0" hangingPunct="1">
        <a:lnSpc>
          <a:spcPct val="90000"/>
        </a:lnSpc>
        <a:spcBef>
          <a:spcPts val="395"/>
        </a:spcBef>
        <a:buFont typeface="Arial" panose="020B0604020202020204" pitchFamily="34" charset="0"/>
        <a:buChar char="•"/>
        <a:defRPr sz="142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22376" rtl="0" eaLnBrk="1" latinLnBrk="0" hangingPunct="1">
        <a:defRPr sz="1422" kern="1200">
          <a:solidFill>
            <a:schemeClr val="tx1"/>
          </a:solidFill>
          <a:latin typeface="+mn-lt"/>
          <a:ea typeface="+mn-ea"/>
          <a:cs typeface="+mn-cs"/>
        </a:defRPr>
      </a:lvl1pPr>
      <a:lvl2pPr marL="361188" algn="l" defTabSz="722376" rtl="0" eaLnBrk="1" latinLnBrk="0" hangingPunct="1">
        <a:defRPr sz="1422" kern="1200">
          <a:solidFill>
            <a:schemeClr val="tx1"/>
          </a:solidFill>
          <a:latin typeface="+mn-lt"/>
          <a:ea typeface="+mn-ea"/>
          <a:cs typeface="+mn-cs"/>
        </a:defRPr>
      </a:lvl2pPr>
      <a:lvl3pPr marL="722376" algn="l" defTabSz="722376" rtl="0" eaLnBrk="1" latinLnBrk="0" hangingPunct="1">
        <a:defRPr sz="1422" kern="1200">
          <a:solidFill>
            <a:schemeClr val="tx1"/>
          </a:solidFill>
          <a:latin typeface="+mn-lt"/>
          <a:ea typeface="+mn-ea"/>
          <a:cs typeface="+mn-cs"/>
        </a:defRPr>
      </a:lvl3pPr>
      <a:lvl4pPr marL="1083564" algn="l" defTabSz="722376" rtl="0" eaLnBrk="1" latinLnBrk="0" hangingPunct="1">
        <a:defRPr sz="1422" kern="1200">
          <a:solidFill>
            <a:schemeClr val="tx1"/>
          </a:solidFill>
          <a:latin typeface="+mn-lt"/>
          <a:ea typeface="+mn-ea"/>
          <a:cs typeface="+mn-cs"/>
        </a:defRPr>
      </a:lvl4pPr>
      <a:lvl5pPr marL="1444752" algn="l" defTabSz="722376" rtl="0" eaLnBrk="1" latinLnBrk="0" hangingPunct="1">
        <a:defRPr sz="1422" kern="1200">
          <a:solidFill>
            <a:schemeClr val="tx1"/>
          </a:solidFill>
          <a:latin typeface="+mn-lt"/>
          <a:ea typeface="+mn-ea"/>
          <a:cs typeface="+mn-cs"/>
        </a:defRPr>
      </a:lvl5pPr>
      <a:lvl6pPr marL="1805940" algn="l" defTabSz="722376" rtl="0" eaLnBrk="1" latinLnBrk="0" hangingPunct="1">
        <a:defRPr sz="1422" kern="1200">
          <a:solidFill>
            <a:schemeClr val="tx1"/>
          </a:solidFill>
          <a:latin typeface="+mn-lt"/>
          <a:ea typeface="+mn-ea"/>
          <a:cs typeface="+mn-cs"/>
        </a:defRPr>
      </a:lvl6pPr>
      <a:lvl7pPr marL="2167128" algn="l" defTabSz="722376" rtl="0" eaLnBrk="1" latinLnBrk="0" hangingPunct="1">
        <a:defRPr sz="1422" kern="1200">
          <a:solidFill>
            <a:schemeClr val="tx1"/>
          </a:solidFill>
          <a:latin typeface="+mn-lt"/>
          <a:ea typeface="+mn-ea"/>
          <a:cs typeface="+mn-cs"/>
        </a:defRPr>
      </a:lvl7pPr>
      <a:lvl8pPr marL="2528316" algn="l" defTabSz="722376" rtl="0" eaLnBrk="1" latinLnBrk="0" hangingPunct="1">
        <a:defRPr sz="1422" kern="1200">
          <a:solidFill>
            <a:schemeClr val="tx1"/>
          </a:solidFill>
          <a:latin typeface="+mn-lt"/>
          <a:ea typeface="+mn-ea"/>
          <a:cs typeface="+mn-cs"/>
        </a:defRPr>
      </a:lvl8pPr>
      <a:lvl9pPr marL="2889504" algn="l" defTabSz="722376" rtl="0" eaLnBrk="1" latinLnBrk="0" hangingPunct="1">
        <a:defRPr sz="142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Inhaltsplatzhalter 3">
            <a:extLst>
              <a:ext uri="{FF2B5EF4-FFF2-40B4-BE49-F238E27FC236}">
                <a16:creationId xmlns:a16="http://schemas.microsoft.com/office/drawing/2014/main" id="{C7C02447-A5EC-44B3-BA13-347F3EB12D4E}"/>
              </a:ext>
            </a:extLst>
          </p:cNvPr>
          <p:cNvSpPr txBox="1">
            <a:spLocks/>
          </p:cNvSpPr>
          <p:nvPr/>
        </p:nvSpPr>
        <p:spPr bwMode="auto">
          <a:xfrm>
            <a:off x="1873193" y="558960"/>
            <a:ext cx="9940299" cy="2692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marL="269875" indent="-269875" algn="l" rtl="0" eaLnBrk="1" fontAlgn="base" hangingPunct="1">
              <a:spcBef>
                <a:spcPts val="400"/>
              </a:spcBef>
              <a:spcAft>
                <a:spcPct val="0"/>
              </a:spcAft>
              <a:buClr>
                <a:schemeClr val="tx1"/>
              </a:buClr>
              <a:buFont typeface="Arial" charset="0"/>
              <a:buChar char="•"/>
              <a:tabLst/>
              <a:defRPr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34988" indent="-265113" algn="l" rtl="0" eaLnBrk="1" fontAlgn="base" hangingPunct="1">
              <a:spcBef>
                <a:spcPts val="400"/>
              </a:spcBef>
              <a:spcAft>
                <a:spcPct val="0"/>
              </a:spcAft>
              <a:buClr>
                <a:schemeClr val="accent3"/>
              </a:buClr>
              <a:buFont typeface="Arial" charset="0"/>
              <a:buChar char="•"/>
              <a:tabLst/>
              <a:defRPr>
                <a:solidFill>
                  <a:schemeClr val="tx1"/>
                </a:solidFill>
                <a:latin typeface="+mn-lt"/>
                <a:ea typeface="+mn-ea"/>
                <a:cs typeface="ＭＳ Ｐゴシック" charset="0"/>
              </a:defRPr>
            </a:lvl2pPr>
            <a:lvl3pPr marL="804863" indent="-269875" algn="l" rtl="0" eaLnBrk="1" fontAlgn="base" hangingPunct="1">
              <a:spcBef>
                <a:spcPts val="400"/>
              </a:spcBef>
              <a:spcAft>
                <a:spcPct val="0"/>
              </a:spcAft>
              <a:buClr>
                <a:schemeClr val="accent3"/>
              </a:buClr>
              <a:buFont typeface="Arial" charset="0"/>
              <a:buChar char="•"/>
              <a:tabLst/>
              <a:defRPr>
                <a:solidFill>
                  <a:schemeClr val="tx1"/>
                </a:solidFill>
                <a:latin typeface="+mn-lt"/>
                <a:ea typeface="Geneva" pitchFamily="-107" charset="-128"/>
                <a:cs typeface="Geneva" pitchFamily="-107" charset="-128"/>
              </a:defRPr>
            </a:lvl3pPr>
            <a:lvl4pPr marL="1090612" indent="-285750" algn="l" rtl="0" eaLnBrk="1" fontAlgn="base" hangingPunct="1">
              <a:spcBef>
                <a:spcPts val="400"/>
              </a:spcBef>
              <a:spcAft>
                <a:spcPct val="0"/>
              </a:spcAft>
              <a:buClr>
                <a:schemeClr val="tx1"/>
              </a:buClr>
              <a:buFont typeface="Arial" charset="0"/>
              <a:buChar char="•"/>
              <a:tabLst/>
              <a:defRPr>
                <a:solidFill>
                  <a:schemeClr val="tx1"/>
                </a:solidFill>
                <a:latin typeface="+mn-lt"/>
                <a:ea typeface="Geneva" pitchFamily="-107" charset="-128"/>
                <a:cs typeface="Geneva" charset="0"/>
              </a:defRPr>
            </a:lvl4pPr>
            <a:lvl5pPr marL="1355725" indent="-285750" algn="l" rtl="0" eaLnBrk="1" fontAlgn="base" hangingPunct="1">
              <a:spcBef>
                <a:spcPts val="400"/>
              </a:spcBef>
              <a:spcAft>
                <a:spcPct val="0"/>
              </a:spcAft>
              <a:buClr>
                <a:schemeClr val="tx1"/>
              </a:buClr>
              <a:buFont typeface="Arial" charset="0"/>
              <a:buChar char="•"/>
              <a:tabLst/>
              <a:defRPr>
                <a:solidFill>
                  <a:schemeClr val="tx1"/>
                </a:solidFill>
                <a:latin typeface="+mn-lt"/>
                <a:ea typeface="Geneva" pitchFamily="-107" charset="-128"/>
                <a:cs typeface="Geneva" charset="0"/>
              </a:defRPr>
            </a:lvl5pPr>
            <a:lvl6pPr marL="2514600" indent="-22860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+mn-lt"/>
                <a:ea typeface="+mn-ea"/>
              </a:defRPr>
            </a:lvl6pPr>
            <a:lvl7pPr marL="2971800" indent="-22860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+mn-lt"/>
                <a:ea typeface="+mn-ea"/>
              </a:defRPr>
            </a:lvl7pPr>
            <a:lvl8pPr marL="3429000" indent="-22860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+mn-lt"/>
                <a:ea typeface="+mn-ea"/>
              </a:defRPr>
            </a:lvl8pPr>
            <a:lvl9pPr marL="3886200" indent="-22860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pPr marL="0" indent="0">
              <a:buClr>
                <a:srgbClr val="000000"/>
              </a:buClr>
              <a:buNone/>
            </a:pPr>
            <a:r>
              <a:rPr lang="en-GB" sz="1600" i="1" kern="0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/>
              </a:rPr>
              <a:t>Arabidopsis thaliana </a:t>
            </a:r>
            <a:r>
              <a:rPr lang="en-GB" sz="1600" kern="0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/>
              </a:rPr>
              <a:t>protein set							   </a:t>
            </a:r>
            <a:r>
              <a:rPr lang="en-GB" sz="1600" i="1" kern="0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/>
              </a:rPr>
              <a:t>Acer </a:t>
            </a:r>
            <a:r>
              <a:rPr lang="en-GB" sz="1600" i="1" kern="0" dirty="0" err="1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/>
              </a:rPr>
              <a:t>yangbiense</a:t>
            </a:r>
            <a:r>
              <a:rPr lang="en-GB" sz="1600" i="1" kern="0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/>
              </a:rPr>
              <a:t> </a:t>
            </a:r>
            <a:r>
              <a:rPr lang="en-GB" sz="1600" kern="0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/>
              </a:rPr>
              <a:t>protein set</a:t>
            </a:r>
          </a:p>
        </p:txBody>
      </p:sp>
      <p:graphicFrame>
        <p:nvGraphicFramePr>
          <p:cNvPr id="8" name="Diagramm 7">
            <a:extLst>
              <a:ext uri="{FF2B5EF4-FFF2-40B4-BE49-F238E27FC236}">
                <a16:creationId xmlns:a16="http://schemas.microsoft.com/office/drawing/2014/main" id="{B1B2EA6C-6E91-476A-BF7C-AF24D72E0AF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7864472"/>
              </p:ext>
            </p:extLst>
          </p:nvPr>
        </p:nvGraphicFramePr>
        <p:xfrm>
          <a:off x="6096000" y="734072"/>
          <a:ext cx="5946222" cy="4246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Diagramm 8">
            <a:extLst>
              <a:ext uri="{FF2B5EF4-FFF2-40B4-BE49-F238E27FC236}">
                <a16:creationId xmlns:a16="http://schemas.microsoft.com/office/drawing/2014/main" id="{82567730-FA4C-413A-AF77-E976AB97B8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0032703"/>
              </p:ext>
            </p:extLst>
          </p:nvPr>
        </p:nvGraphicFramePr>
        <p:xfrm>
          <a:off x="297332" y="1147716"/>
          <a:ext cx="5798668" cy="34190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Rechteck 5">
            <a:extLst>
              <a:ext uri="{FF2B5EF4-FFF2-40B4-BE49-F238E27FC236}">
                <a16:creationId xmlns:a16="http://schemas.microsoft.com/office/drawing/2014/main" id="{EFFDC072-DCD6-4555-8C4F-25DAACD657A7}"/>
              </a:ext>
            </a:extLst>
          </p:cNvPr>
          <p:cNvSpPr/>
          <p:nvPr/>
        </p:nvSpPr>
        <p:spPr>
          <a:xfrm>
            <a:off x="2502874" y="4492313"/>
            <a:ext cx="7547059" cy="292388"/>
          </a:xfrm>
          <a:prstGeom prst="rect">
            <a:avLst/>
          </a:prstGeom>
        </p:spPr>
        <p:txBody>
          <a:bodyPr wrap="square" numCol="3">
            <a:spAutoFit/>
          </a:bodyPr>
          <a:lstStyle/>
          <a:p>
            <a:pPr marL="171450" indent="-171450">
              <a:buClr>
                <a:srgbClr val="7B3294"/>
              </a:buClr>
              <a:buSzPct val="120000"/>
              <a:buFont typeface="Arial" panose="020B0604020202020204" pitchFamily="34" charset="0"/>
              <a:buChar char="•"/>
            </a:pPr>
            <a:r>
              <a:rPr lang="en-GB" sz="13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P</a:t>
            </a:r>
            <a:r>
              <a:rPr lang="en-GB" sz="12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</a:t>
            </a:r>
            <a:r>
              <a:rPr lang="en-GB" sz="13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contigs with CRBB</a:t>
            </a:r>
          </a:p>
          <a:p>
            <a:pPr marL="171450" indent="-171450">
              <a:buClr>
                <a:srgbClr val="A6DBA0"/>
              </a:buClr>
              <a:buSzPct val="120000"/>
              <a:buFont typeface="Arial" panose="020B0604020202020204" pitchFamily="34" charset="0"/>
              <a:buChar char="•"/>
            </a:pPr>
            <a:r>
              <a:rPr lang="en-GB" sz="13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P reference with CRBB</a:t>
            </a:r>
          </a:p>
          <a:p>
            <a:pPr marL="171450" indent="-171450">
              <a:buClr>
                <a:srgbClr val="008837"/>
              </a:buClr>
              <a:buSzPct val="120000"/>
              <a:buFont typeface="Arial" panose="020B0604020202020204" pitchFamily="34" charset="0"/>
              <a:buChar char="•"/>
            </a:pPr>
            <a:r>
              <a:rPr lang="en-GB" sz="13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Reference coverage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250F2BE8-BB5F-4730-80DF-EDD10F83E463}"/>
              </a:ext>
            </a:extLst>
          </p:cNvPr>
          <p:cNvSpPr txBox="1"/>
          <p:nvPr/>
        </p:nvSpPr>
        <p:spPr>
          <a:xfrm>
            <a:off x="1270239" y="929826"/>
            <a:ext cx="42444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A. </a:t>
            </a:r>
            <a:r>
              <a:rPr lang="de-DE" sz="1200" i="1" dirty="0" err="1">
                <a:solidFill>
                  <a:schemeClr val="tx1">
                    <a:lumMod val="65000"/>
                    <a:lumOff val="35000"/>
                  </a:schemeClr>
                </a:solidFill>
              </a:rPr>
              <a:t>thaliana</a:t>
            </a:r>
            <a:r>
              <a:rPr lang="de-DE" sz="1200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</a:t>
            </a:r>
            <a:r>
              <a:rPr lang="de-DE" sz="12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(2x)	  			</a:t>
            </a:r>
            <a:r>
              <a:rPr lang="de-DE" sz="1200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A. </a:t>
            </a:r>
            <a:r>
              <a:rPr lang="de-DE" sz="1200" i="1" dirty="0" err="1">
                <a:solidFill>
                  <a:schemeClr val="tx1">
                    <a:lumMod val="65000"/>
                    <a:lumOff val="35000"/>
                  </a:schemeClr>
                </a:solidFill>
              </a:rPr>
              <a:t>thaliana</a:t>
            </a:r>
            <a:r>
              <a:rPr lang="de-DE" sz="1200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</a:t>
            </a:r>
            <a:r>
              <a:rPr lang="de-DE" sz="12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(4x)</a:t>
            </a:r>
            <a:endParaRPr lang="en-US" sz="1200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cxnSp>
        <p:nvCxnSpPr>
          <p:cNvPr id="12" name="Gerader Verbinder 11">
            <a:extLst>
              <a:ext uri="{FF2B5EF4-FFF2-40B4-BE49-F238E27FC236}">
                <a16:creationId xmlns:a16="http://schemas.microsoft.com/office/drawing/2014/main" id="{D6E48994-3CA6-46C5-A57C-A6BEA92461A0}"/>
              </a:ext>
            </a:extLst>
          </p:cNvPr>
          <p:cNvCxnSpPr>
            <a:cxnSpLocks/>
          </p:cNvCxnSpPr>
          <p:nvPr/>
        </p:nvCxnSpPr>
        <p:spPr>
          <a:xfrm>
            <a:off x="3262463" y="929826"/>
            <a:ext cx="0" cy="3290834"/>
          </a:xfrm>
          <a:prstGeom prst="line">
            <a:avLst/>
          </a:prstGeom>
          <a:ln w="12700">
            <a:solidFill>
              <a:schemeClr val="bg2">
                <a:lumMod val="9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feld 12">
            <a:extLst>
              <a:ext uri="{FF2B5EF4-FFF2-40B4-BE49-F238E27FC236}">
                <a16:creationId xmlns:a16="http://schemas.microsoft.com/office/drawing/2014/main" id="{A21316B9-384E-4F88-838B-C1B15C9B10A0}"/>
              </a:ext>
            </a:extLst>
          </p:cNvPr>
          <p:cNvSpPr txBox="1"/>
          <p:nvPr/>
        </p:nvSpPr>
        <p:spPr>
          <a:xfrm>
            <a:off x="7191132" y="929826"/>
            <a:ext cx="4622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A. </a:t>
            </a:r>
            <a:r>
              <a:rPr lang="de-DE" sz="1200" i="1" dirty="0" err="1">
                <a:solidFill>
                  <a:schemeClr val="tx1">
                    <a:lumMod val="65000"/>
                    <a:lumOff val="35000"/>
                  </a:schemeClr>
                </a:solidFill>
              </a:rPr>
              <a:t>platanoides</a:t>
            </a:r>
            <a:r>
              <a:rPr lang="de-DE" sz="1200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</a:t>
            </a:r>
            <a:r>
              <a:rPr lang="de-DE" sz="12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(2x)	  		      </a:t>
            </a:r>
            <a:r>
              <a:rPr lang="de-DE" sz="1200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A. pseudoplatanus </a:t>
            </a:r>
            <a:r>
              <a:rPr lang="de-DE" sz="12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(4x)</a:t>
            </a:r>
            <a:endParaRPr lang="en-US" sz="1200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cxnSp>
        <p:nvCxnSpPr>
          <p:cNvPr id="14" name="Gerader Verbinder 13">
            <a:extLst>
              <a:ext uri="{FF2B5EF4-FFF2-40B4-BE49-F238E27FC236}">
                <a16:creationId xmlns:a16="http://schemas.microsoft.com/office/drawing/2014/main" id="{E1274C46-55ED-4693-B64E-858A64E64BD3}"/>
              </a:ext>
            </a:extLst>
          </p:cNvPr>
          <p:cNvCxnSpPr>
            <a:cxnSpLocks/>
          </p:cNvCxnSpPr>
          <p:nvPr/>
        </p:nvCxnSpPr>
        <p:spPr>
          <a:xfrm>
            <a:off x="9183356" y="939441"/>
            <a:ext cx="0" cy="3281219"/>
          </a:xfrm>
          <a:prstGeom prst="line">
            <a:avLst/>
          </a:prstGeom>
          <a:ln w="12700">
            <a:solidFill>
              <a:schemeClr val="bg2">
                <a:lumMod val="9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27250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AIT RZ">
    <a:dk1>
      <a:srgbClr val="000000"/>
    </a:dk1>
    <a:lt1>
      <a:srgbClr val="FFFFFF"/>
    </a:lt1>
    <a:dk2>
      <a:srgbClr val="790B1A"/>
    </a:dk2>
    <a:lt2>
      <a:srgbClr val="FFFFFF"/>
    </a:lt2>
    <a:accent1>
      <a:srgbClr val="790B1A"/>
    </a:accent1>
    <a:accent2>
      <a:srgbClr val="5D6C74"/>
    </a:accent2>
    <a:accent3>
      <a:srgbClr val="40AA9B"/>
    </a:accent3>
    <a:accent4>
      <a:srgbClr val="330040"/>
    </a:accent4>
    <a:accent5>
      <a:srgbClr val="BDBDBD"/>
    </a:accent5>
    <a:accent6>
      <a:srgbClr val="000000"/>
    </a:accent6>
    <a:hlink>
      <a:srgbClr val="790B1A"/>
    </a:hlink>
    <a:folHlink>
      <a:srgbClr val="790B1A"/>
    </a:folHlink>
  </a:clrScheme>
  <a:fontScheme name="Arial">
    <a:majorFont>
      <a:latin typeface="Arial" panose="020B0604020202020204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ajorFont>
    <a:minorFont>
      <a:latin typeface="Arial" panose="020B0604020202020204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AIT RZ">
    <a:dk1>
      <a:srgbClr val="000000"/>
    </a:dk1>
    <a:lt1>
      <a:srgbClr val="FFFFFF"/>
    </a:lt1>
    <a:dk2>
      <a:srgbClr val="790B1A"/>
    </a:dk2>
    <a:lt2>
      <a:srgbClr val="FFFFFF"/>
    </a:lt2>
    <a:accent1>
      <a:srgbClr val="790B1A"/>
    </a:accent1>
    <a:accent2>
      <a:srgbClr val="5D6C74"/>
    </a:accent2>
    <a:accent3>
      <a:srgbClr val="40AA9B"/>
    </a:accent3>
    <a:accent4>
      <a:srgbClr val="330040"/>
    </a:accent4>
    <a:accent5>
      <a:srgbClr val="BDBDBD"/>
    </a:accent5>
    <a:accent6>
      <a:srgbClr val="000000"/>
    </a:accent6>
    <a:hlink>
      <a:srgbClr val="790B1A"/>
    </a:hlink>
    <a:folHlink>
      <a:srgbClr val="790B1A"/>
    </a:folHlink>
  </a:clrScheme>
  <a:fontScheme name="Arial">
    <a:majorFont>
      <a:latin typeface="Arial" panose="020B0604020202020204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ajorFont>
    <a:minorFont>
      <a:latin typeface="Arial" panose="020B0604020202020204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6</Words>
  <Application>Microsoft Office PowerPoint</Application>
  <PresentationFormat>Benutzerdefiniert</PresentationFormat>
  <Paragraphs>8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dritsch Silvia</dc:creator>
  <cp:lastModifiedBy>Madritsch Silvia</cp:lastModifiedBy>
  <cp:revision>21</cp:revision>
  <dcterms:created xsi:type="dcterms:W3CDTF">2020-09-08T09:26:37Z</dcterms:created>
  <dcterms:modified xsi:type="dcterms:W3CDTF">2020-11-09T10:02:18Z</dcterms:modified>
</cp:coreProperties>
</file>